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93" d="100"/>
          <a:sy n="93" d="100"/>
        </p:scale>
        <p:origin x="49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20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770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828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342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53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510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831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73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47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838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82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7DC95-6472-4865-B01D-AC4E3756DFC9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8CC51-EB27-456D-AFA2-F5474F571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516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3016" y="2916192"/>
            <a:ext cx="3929450" cy="265258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319" y="2916192"/>
            <a:ext cx="3860697" cy="265258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50660" y="271850"/>
            <a:ext cx="3805882" cy="25454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53016" y="271849"/>
            <a:ext cx="3871784" cy="2611394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2319" y="271849"/>
            <a:ext cx="3860697" cy="261139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13842" y="370702"/>
            <a:ext cx="46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577385" y="362464"/>
            <a:ext cx="46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410196" y="361093"/>
            <a:ext cx="46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33163" y="3015769"/>
            <a:ext cx="46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596075" y="3019202"/>
            <a:ext cx="46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8" name="Rectangle 17"/>
          <p:cNvSpPr/>
          <p:nvPr/>
        </p:nvSpPr>
        <p:spPr>
          <a:xfrm>
            <a:off x="192319" y="5867806"/>
            <a:ext cx="119996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Quantile-quant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ing expected vs observed negative log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) values generated from the GWAS for 19,281 SNPs 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GR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201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2018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2019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BLUE dat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ts across 246 whe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270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5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, Tyler</dc:creator>
  <cp:lastModifiedBy>Gordon, Tyler</cp:lastModifiedBy>
  <cp:revision>11</cp:revision>
  <dcterms:created xsi:type="dcterms:W3CDTF">2019-11-22T21:51:29Z</dcterms:created>
  <dcterms:modified xsi:type="dcterms:W3CDTF">2019-11-27T18:12:59Z</dcterms:modified>
</cp:coreProperties>
</file>